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4" r:id="rId3"/>
    <p:sldId id="256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59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7/07/2017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64961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51055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7/07/2017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92578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attaglia et al (2017) Diabetologia DOI 10.1007/s00125-017-4384-2</a:t>
            </a:r>
          </a:p>
          <a:p>
            <a:r>
              <a:rPr lang="en-GB" sz="1400" dirty="0"/>
              <a:t>© </a:t>
            </a:r>
            <a:r>
              <a:rPr lang="en-GB" dirty="0"/>
              <a:t>The Authors 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298064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ype 1 diabetes: a disease with three stages of pathology and</a:t>
            </a:r>
          </a:p>
          <a:p>
            <a:r>
              <a:rPr lang="en-US" sz="2000" b="1" dirty="0"/>
              <a:t>various opportunities for intervention with disease-modifying therapies</a:t>
            </a:r>
          </a:p>
          <a:p>
            <a:r>
              <a:rPr lang="en-GB" sz="2000" b="1" dirty="0"/>
              <a:t>and mechanistic analysi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A9091F7-6E08-4116-B66D-EB5C56A55B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1880" y="132004"/>
            <a:ext cx="4846383" cy="60579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92578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attaglia et al (2017) Diabetologia DOI 10.1007/s00125-017-4384-2</a:t>
            </a:r>
          </a:p>
          <a:p>
            <a:r>
              <a:rPr lang="en-GB" sz="1400" dirty="0"/>
              <a:t>© </a:t>
            </a:r>
            <a:r>
              <a:rPr lang="en-GB" dirty="0"/>
              <a:t>The Authors 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55576" y="476672"/>
            <a:ext cx="85879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rchived TrialNet samples distributed over the years</a:t>
            </a:r>
            <a:endParaRPr lang="en-GB" sz="24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8AE28B0-D64C-41A1-B7B5-03D0BC6ADF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9712" y="1490990"/>
            <a:ext cx="5525600" cy="4121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699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61248"/>
            <a:ext cx="7128792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Battaglia et al (2017) Diabetologia DOI 10.1007/s00125-017-4384-2</a:t>
            </a:r>
          </a:p>
          <a:p>
            <a:r>
              <a:rPr lang="en-GB" sz="1400" dirty="0"/>
              <a:t>© </a:t>
            </a:r>
            <a:r>
              <a:rPr lang="en-GB" dirty="0"/>
              <a:t>The Authors 2017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575392"/>
            <a:ext cx="8712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rchived TrialNet samples distributed to perform ancillary studies</a:t>
            </a:r>
            <a:endParaRPr lang="en-GB" sz="24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124E703-3E5D-4CBF-B361-178DEFF7C9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904" y="2069196"/>
            <a:ext cx="4607250" cy="320664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A5A736A-35D3-4D3C-BB53-1AD575B79C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60322" y="1268760"/>
            <a:ext cx="4608512" cy="399873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CECECFF-F499-4A24-93E4-FC70B38454F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95736" y="1916832"/>
            <a:ext cx="2276475" cy="113347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92578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Battaglia et al (2017) Diabetologia DOI 10.1007/s00125-017-4384-2</a:t>
            </a:r>
          </a:p>
          <a:p>
            <a:r>
              <a:rPr lang="en-GB" sz="1400" dirty="0"/>
              <a:t>© </a:t>
            </a:r>
            <a:r>
              <a:rPr lang="en-GB" dirty="0"/>
              <a:t>The Authors 2017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95536" y="536775"/>
            <a:ext cx="8587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hord diagram of </a:t>
            </a:r>
            <a:r>
              <a:rPr lang="en-GB" sz="2000" b="1" dirty="0"/>
              <a:t>ancillary studies (AS) </a:t>
            </a:r>
            <a:r>
              <a:rPr lang="en-US" sz="2000" b="1" dirty="0"/>
              <a:t>performed on the same TrialNet donor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B524892-6E27-49FD-8BC0-8CDA13C759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5696" y="902802"/>
            <a:ext cx="6134658" cy="5262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91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114</Words>
  <Application>Microsoft Office PowerPoint</Application>
  <PresentationFormat>On-screen Show (4:3)</PresentationFormat>
  <Paragraphs>21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Katherine Thomasset</cp:lastModifiedBy>
  <cp:revision>31</cp:revision>
  <dcterms:created xsi:type="dcterms:W3CDTF">2016-06-15T12:53:43Z</dcterms:created>
  <dcterms:modified xsi:type="dcterms:W3CDTF">2017-07-27T09:39:56Z</dcterms:modified>
</cp:coreProperties>
</file>